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75" d="100"/>
          <a:sy n="75" d="100"/>
        </p:scale>
        <p:origin x="-1158" y="12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51CA-2609-4A40-B20B-94637BFB0119}" type="datetimeFigureOut">
              <a:rPr lang="en-US" smtClean="0"/>
              <a:pPr/>
              <a:t>3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A10E-D8B4-4A61-BA84-BF129C93F6B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51CA-2609-4A40-B20B-94637BFB0119}" type="datetimeFigureOut">
              <a:rPr lang="en-US" smtClean="0"/>
              <a:pPr/>
              <a:t>3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A10E-D8B4-4A61-BA84-BF129C93F6B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51CA-2609-4A40-B20B-94637BFB0119}" type="datetimeFigureOut">
              <a:rPr lang="en-US" smtClean="0"/>
              <a:pPr/>
              <a:t>3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A10E-D8B4-4A61-BA84-BF129C93F6B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51CA-2609-4A40-B20B-94637BFB0119}" type="datetimeFigureOut">
              <a:rPr lang="en-US" smtClean="0"/>
              <a:pPr/>
              <a:t>3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A10E-D8B4-4A61-BA84-BF129C93F6B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51CA-2609-4A40-B20B-94637BFB0119}" type="datetimeFigureOut">
              <a:rPr lang="en-US" smtClean="0"/>
              <a:pPr/>
              <a:t>3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A10E-D8B4-4A61-BA84-BF129C93F6B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51CA-2609-4A40-B20B-94637BFB0119}" type="datetimeFigureOut">
              <a:rPr lang="en-US" smtClean="0"/>
              <a:pPr/>
              <a:t>3/2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A10E-D8B4-4A61-BA84-BF129C93F6B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2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2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51CA-2609-4A40-B20B-94637BFB0119}" type="datetimeFigureOut">
              <a:rPr lang="en-US" smtClean="0"/>
              <a:pPr/>
              <a:t>3/21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A10E-D8B4-4A61-BA84-BF129C93F6B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51CA-2609-4A40-B20B-94637BFB0119}" type="datetimeFigureOut">
              <a:rPr lang="en-US" smtClean="0"/>
              <a:pPr/>
              <a:t>3/21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A10E-D8B4-4A61-BA84-BF129C93F6B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51CA-2609-4A40-B20B-94637BFB0119}" type="datetimeFigureOut">
              <a:rPr lang="en-US" smtClean="0"/>
              <a:pPr/>
              <a:t>3/21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A10E-D8B4-4A61-BA84-BF129C93F6B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1" y="273052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51CA-2609-4A40-B20B-94637BFB0119}" type="datetimeFigureOut">
              <a:rPr lang="en-US" smtClean="0"/>
              <a:pPr/>
              <a:t>3/2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A10E-D8B4-4A61-BA84-BF129C93F6B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51CA-2609-4A40-B20B-94637BFB0119}" type="datetimeFigureOut">
              <a:rPr lang="en-US" smtClean="0"/>
              <a:pPr/>
              <a:t>3/2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A10E-D8B4-4A61-BA84-BF129C93F6B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FE51CA-2609-4A40-B20B-94637BFB0119}" type="datetimeFigureOut">
              <a:rPr lang="en-US" smtClean="0"/>
              <a:pPr/>
              <a:t>3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D5A10E-D8B4-4A61-BA84-BF129C93F6B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E:\专业学习\manuscript\Figs\submit-figs\FigS2.tif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524000" y="594529"/>
            <a:ext cx="5791200" cy="3934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Rectangle 2"/>
          <p:cNvSpPr/>
          <p:nvPr/>
        </p:nvSpPr>
        <p:spPr>
          <a:xfrm>
            <a:off x="1295400" y="4648202"/>
            <a:ext cx="6629400" cy="1384995"/>
          </a:xfrm>
          <a:prstGeom prst="rect">
            <a:avLst/>
          </a:prstGeom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.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T. </a:t>
            </a:r>
            <a:r>
              <a:rPr lang="en-US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gondii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arasites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mmunoblotted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with anti-rTgPuf1 polyclonal antibodies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Left panel: Expression of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gPuf1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untransfect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H∆Ku8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tachyzoite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Parasite lysates were probed with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reimmun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immune serum against rTgPuf1. The arrow indicates the predicted TgPuf1 protein, while the others bands are probably cross-reacting proteins. Right panel: Expression of TgPuf1 i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tachyzoite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radyzoite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as determined by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mmunoblottin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ith anti-rTgPuf1 polyclonal antibody. The two stages were differentiated by antibodies against bradyzoite-specific BAG1. Anti-β-tubulin antibody served as a protein loading control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96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Toshib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liwangc</dc:creator>
  <cp:lastModifiedBy>微软用户</cp:lastModifiedBy>
  <cp:revision>7</cp:revision>
  <dcterms:created xsi:type="dcterms:W3CDTF">2014-02-05T04:36:47Z</dcterms:created>
  <dcterms:modified xsi:type="dcterms:W3CDTF">2014-03-21T15:09:04Z</dcterms:modified>
</cp:coreProperties>
</file>